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50" d="100"/>
          <a:sy n="150" d="100"/>
        </p:scale>
        <p:origin x="65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6D7D6CA-D02D-7D66-0C4A-4891A8309D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141F1D6-0894-8D92-943F-4D12C17467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876AF1B-798E-92DC-3471-192C85296E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D85E-11CD-4653-A724-3B1511C1D014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A6CDD9B-115B-3376-83B6-21164401DF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A94DD37-3708-7BF0-B819-D74825940B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1F22B-0A05-40D2-884C-20B0D5B1C1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15989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18BE6AC-F90F-7DB4-E8F5-B7F09B607E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0BDD5B1-AD40-E7E8-A21B-1016F6C021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5180621-0A91-6924-F266-6D7F1AD51F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D85E-11CD-4653-A724-3B1511C1D014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52FC31A-A996-88F6-9A4A-0A454431F5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83BCADB-04D0-4562-3E1E-38B5467962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1F22B-0A05-40D2-884C-20B0D5B1C1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07596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C655EC2F-6624-BD99-8B6D-7D8E0AF93E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EF64FA2-1DC4-EB4F-BE32-FD08CE1D47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CC77006-EC90-E246-7B48-48B1ED03AF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D85E-11CD-4653-A724-3B1511C1D014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CEC34F4-19D9-6A15-4D77-13655AFBD7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A4EEA0C-CD5C-5421-4DD3-A726BE9995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1F22B-0A05-40D2-884C-20B0D5B1C1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64163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EC5C32-EAC3-6C3F-268D-D79E4FD1F4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4ACD186-D16D-2D1D-D630-90D052A442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B59DC8D-9E0C-4743-36F7-BA41AEB4F4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D85E-11CD-4653-A724-3B1511C1D014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A733E1D-51C9-A8A6-3E5A-5190062D61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FB6226A-D4D5-F915-E2CA-91883EA14B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1F22B-0A05-40D2-884C-20B0D5B1C1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40074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72FE2F-492A-6B3C-3F8D-643D93E3A5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961FA0A-1052-08D4-715D-BE49F72291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C746CAA-128B-C7FB-F4A1-A91EE47A32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D85E-11CD-4653-A724-3B1511C1D014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15FE282-DF11-E80C-B88E-74A4B01157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CB17DC0-23DB-C17E-5614-FF7B88B19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1F22B-0A05-40D2-884C-20B0D5B1C1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40412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6087792-0FB7-7A60-2E35-6AA42FBFA5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29B2BCA-AC14-668F-76D8-2BFB534E5B2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6CAB568-ECB7-6473-7A61-B6E91F7715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38C76E3-BF3C-DAE3-46D5-7C34D98E33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D85E-11CD-4653-A724-3B1511C1D014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1660DFC-FCCD-58CA-57D4-3B547CD45B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E944F64-7BD3-1207-FC8B-00E6BE1734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1F22B-0A05-40D2-884C-20B0D5B1C1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7589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43BAD88-B293-5ACF-95F3-7DDE68F189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D3A3DAC-3845-B83B-5B5F-B60E274D10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C3CF65C-E413-A8B2-A57B-FED46A9CA3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3C2EEC4-9D8F-FDAA-3B1B-F8C87E335D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173D64C-70AC-7E3D-AB9E-80F8B199FAA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66D719E-E154-F0DD-383C-8949F01219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D85E-11CD-4653-A724-3B1511C1D014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FD8BB27-54CA-F599-D1D7-57499D5F19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90A5C53-9E4E-686F-1673-7C0CF0DAC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1F22B-0A05-40D2-884C-20B0D5B1C1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71665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8786660-D971-5CC7-DAF8-D0E3C67BDB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348ADB9-E20D-F6A8-162F-A61A0D2007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D85E-11CD-4653-A724-3B1511C1D014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C8723A0-A418-7A97-637B-CBFAFF1905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10055B4-1B3E-8BC2-9FB8-9946DEA20F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1F22B-0A05-40D2-884C-20B0D5B1C1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1427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A2435E0-56A8-CBFD-D8A4-F67C4AD562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D85E-11CD-4653-A724-3B1511C1D014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A5E5682E-6772-93D9-6A9A-1052C64C62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4AD97BF-72F9-C68A-A8EC-C5EF75BD93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1F22B-0A05-40D2-884C-20B0D5B1C1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72263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3329E76-2465-AA96-F210-195051EC9F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6351CAE-DDD6-EDE9-0F4D-3CACFD26EC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FA8CCBB-78D3-4190-BDDF-CA91C9A261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1BE22CD-1100-D614-C856-662C76A1FF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D85E-11CD-4653-A724-3B1511C1D014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E8EF555-97A9-9A88-D817-E0FDDBD6B6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6B5F313-6038-2573-4932-C9FA4E8343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1F22B-0A05-40D2-884C-20B0D5B1C1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60689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CFAAB4-4C57-6E8C-59B2-9672B0A0DC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AA86F7C-9721-4192-A31D-5E1EE3285AB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A63830C-8B1A-3127-258C-6B8B09541C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5D01292-501A-8F34-F33C-0CED377A17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8D85E-11CD-4653-A724-3B1511C1D014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47A3448-96BE-1623-2266-CF898C1764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F9C3BDC-6396-A160-213E-6BB0621D97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1F22B-0A05-40D2-884C-20B0D5B1C1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28721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65C68EF-26E0-C1F0-03F3-667EEB55A3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EDD9301-688D-D495-F45D-18E6399053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6D9126E-3C22-B1B2-47CA-2719CCFEDB0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D8D85E-11CD-4653-A724-3B1511C1D014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FCB7670-1287-DA58-4AEB-9AB0A67086B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765BFD9-AFB1-7D28-9478-B4DCF3B4F55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11F22B-0A05-40D2-884C-20B0D5B1C1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54431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png"/><Relationship Id="rId11" Type="http://schemas.openxmlformats.org/officeDocument/2006/relationships/image" Target="../media/image20.png"/><Relationship Id="rId5" Type="http://schemas.openxmlformats.org/officeDocument/2006/relationships/image" Target="../media/image14.png"/><Relationship Id="rId10" Type="http://schemas.openxmlformats.org/officeDocument/2006/relationships/image" Target="../media/image19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5548EBC-1C9B-9BF8-2C43-9110F480A8F0}"/>
              </a:ext>
            </a:extLst>
          </p:cNvPr>
          <p:cNvSpPr txBox="1"/>
          <p:nvPr/>
        </p:nvSpPr>
        <p:spPr>
          <a:xfrm>
            <a:off x="291047" y="2821127"/>
            <a:ext cx="1923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NA-Val</a:t>
            </a:r>
          </a:p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49-1612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A09E5D7-C244-0AFD-B67D-555A8F5F8A10}"/>
              </a:ext>
            </a:extLst>
          </p:cNvPr>
          <p:cNvSpPr txBox="1"/>
          <p:nvPr/>
        </p:nvSpPr>
        <p:spPr>
          <a:xfrm>
            <a:off x="2631206" y="2821127"/>
            <a:ext cx="1923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NA-Leu</a:t>
            </a:r>
          </a:p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89-2750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00FAADB-0998-77A1-E606-CCB7225BF3BD}"/>
              </a:ext>
            </a:extLst>
          </p:cNvPr>
          <p:cNvSpPr txBox="1"/>
          <p:nvPr/>
        </p:nvSpPr>
        <p:spPr>
          <a:xfrm>
            <a:off x="4898732" y="2820229"/>
            <a:ext cx="1923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NA-Ala</a:t>
            </a:r>
          </a:p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750-2812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8608EBD2-5ED5-DA0E-7905-7DDB76AEA3E2}"/>
              </a:ext>
            </a:extLst>
          </p:cNvPr>
          <p:cNvSpPr txBox="1"/>
          <p:nvPr/>
        </p:nvSpPr>
        <p:spPr>
          <a:xfrm>
            <a:off x="7473079" y="2820198"/>
            <a:ext cx="1923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NA-Pro</a:t>
            </a:r>
          </a:p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815-2881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0B322B25-BACC-1AF3-670C-50E2F2E5FC08}"/>
              </a:ext>
            </a:extLst>
          </p:cNvPr>
          <p:cNvSpPr txBox="1"/>
          <p:nvPr/>
        </p:nvSpPr>
        <p:spPr>
          <a:xfrm>
            <a:off x="10042177" y="2820198"/>
            <a:ext cx="1923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NA-Tyr</a:t>
            </a:r>
          </a:p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912-5974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EF03165D-9C33-B1CE-4C75-278E08BE904D}"/>
              </a:ext>
            </a:extLst>
          </p:cNvPr>
          <p:cNvSpPr txBox="1"/>
          <p:nvPr/>
        </p:nvSpPr>
        <p:spPr>
          <a:xfrm>
            <a:off x="280842" y="6042454"/>
            <a:ext cx="1923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NA-</a:t>
            </a:r>
            <a:r>
              <a:rPr kumimoji="1" lang="en-US" altLang="ja-JP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p</a:t>
            </a:r>
            <a:endParaRPr kumimoji="1"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977-6041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80571BA-DA3B-E5D4-C038-A1B17BB58ECD}"/>
              </a:ext>
            </a:extLst>
          </p:cNvPr>
          <p:cNvSpPr txBox="1"/>
          <p:nvPr/>
        </p:nvSpPr>
        <p:spPr>
          <a:xfrm>
            <a:off x="2623599" y="6042454"/>
            <a:ext cx="1923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NA-Asp</a:t>
            </a:r>
          </a:p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453-7515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AD8B2EF-9195-AAD5-CB68-7A24D9BAF3EE}"/>
              </a:ext>
            </a:extLst>
          </p:cNvPr>
          <p:cNvSpPr txBox="1"/>
          <p:nvPr/>
        </p:nvSpPr>
        <p:spPr>
          <a:xfrm>
            <a:off x="5134386" y="6045715"/>
            <a:ext cx="1923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NA-</a:t>
            </a:r>
            <a:r>
              <a:rPr kumimoji="1" lang="en-US" altLang="ja-JP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e</a:t>
            </a:r>
            <a:endParaRPr kumimoji="1"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17-7579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06A572DF-C4EA-06ED-F868-792AC65116BA}"/>
              </a:ext>
            </a:extLst>
          </p:cNvPr>
          <p:cNvSpPr txBox="1"/>
          <p:nvPr/>
        </p:nvSpPr>
        <p:spPr>
          <a:xfrm>
            <a:off x="7517146" y="6052056"/>
            <a:ext cx="1923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NA-</a:t>
            </a:r>
            <a:r>
              <a:rPr kumimoji="1" lang="en-US" altLang="ja-JP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</a:t>
            </a:r>
            <a:endParaRPr kumimoji="1"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257-8318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DD659D03-5B5C-7E90-83CF-AA390AB09E9D}"/>
              </a:ext>
            </a:extLst>
          </p:cNvPr>
          <p:cNvSpPr txBox="1"/>
          <p:nvPr/>
        </p:nvSpPr>
        <p:spPr>
          <a:xfrm>
            <a:off x="9843703" y="6048225"/>
            <a:ext cx="1923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NA-His</a:t>
            </a:r>
          </a:p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320-8383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9373ECFB-F8F8-6CB8-A879-58444B04879D}"/>
              </a:ext>
            </a:extLst>
          </p:cNvPr>
          <p:cNvSpPr txBox="1"/>
          <p:nvPr/>
        </p:nvSpPr>
        <p:spPr>
          <a:xfrm>
            <a:off x="0" y="6444504"/>
            <a:ext cx="121920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2. The secondary structures of the 23 tRNAs encoded in the mitochondrial genome of </a:t>
            </a:r>
            <a:r>
              <a:rPr lang="en-US" altLang="ja-JP" sz="105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urilla</a:t>
            </a:r>
            <a:r>
              <a:rPr lang="en-US" altLang="ja-JP" sz="10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aziliana</a:t>
            </a:r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types of base pairing are indicated by the varying styles of bonds between bases. Each structure is accompanied by the corresponding tRNA type and its position within the </a:t>
            </a:r>
            <a:r>
              <a:rPr lang="en-US" altLang="ja-JP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DNA</a:t>
            </a:r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kumimoji="1" lang="en-US" altLang="ja-JP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 descr="グラフ&#10;&#10;中程度の精度で自動的に生成された説明">
            <a:extLst>
              <a:ext uri="{FF2B5EF4-FFF2-40B4-BE49-F238E27FC236}">
                <a16:creationId xmlns:a16="http://schemas.microsoft.com/office/drawing/2014/main" id="{2FE28393-CB82-ADF6-C256-99649C11473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60" r="30129" b="7390"/>
          <a:stretch/>
        </p:blipFill>
        <p:spPr>
          <a:xfrm>
            <a:off x="99593" y="0"/>
            <a:ext cx="2297283" cy="2822149"/>
          </a:xfrm>
          <a:prstGeom prst="rect">
            <a:avLst/>
          </a:prstGeom>
        </p:spPr>
      </p:pic>
      <p:pic>
        <p:nvPicPr>
          <p:cNvPr id="7" name="図 6" descr="グラフ&#10;&#10;低い精度で自動的に生成された説明">
            <a:extLst>
              <a:ext uri="{FF2B5EF4-FFF2-40B4-BE49-F238E27FC236}">
                <a16:creationId xmlns:a16="http://schemas.microsoft.com/office/drawing/2014/main" id="{27323266-72EB-BB17-5691-19661BF3A77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04" r="30104" b="7203"/>
          <a:stretch/>
        </p:blipFill>
        <p:spPr>
          <a:xfrm>
            <a:off x="2496469" y="0"/>
            <a:ext cx="2166398" cy="2822149"/>
          </a:xfrm>
          <a:prstGeom prst="rect">
            <a:avLst/>
          </a:prstGeom>
        </p:spPr>
      </p:pic>
      <p:pic>
        <p:nvPicPr>
          <p:cNvPr id="13" name="図 12" descr="ダイアグラム&#10;&#10;自動的に生成された説明">
            <a:extLst>
              <a:ext uri="{FF2B5EF4-FFF2-40B4-BE49-F238E27FC236}">
                <a16:creationId xmlns:a16="http://schemas.microsoft.com/office/drawing/2014/main" id="{6E7F3EE1-EADB-BC20-B874-7F3C55F2562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48" r="29896" b="7390"/>
          <a:stretch/>
        </p:blipFill>
        <p:spPr>
          <a:xfrm>
            <a:off x="4762460" y="0"/>
            <a:ext cx="2190650" cy="2822149"/>
          </a:xfrm>
          <a:prstGeom prst="rect">
            <a:avLst/>
          </a:prstGeom>
        </p:spPr>
      </p:pic>
      <p:pic>
        <p:nvPicPr>
          <p:cNvPr id="17" name="図 16" descr="ダイアグラム&#10;&#10;自動的に生成された説明">
            <a:extLst>
              <a:ext uri="{FF2B5EF4-FFF2-40B4-BE49-F238E27FC236}">
                <a16:creationId xmlns:a16="http://schemas.microsoft.com/office/drawing/2014/main" id="{ABF7246F-7997-8187-8674-05C2C7BFFA1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11" t="4685" r="24842" b="10933"/>
          <a:stretch/>
        </p:blipFill>
        <p:spPr>
          <a:xfrm>
            <a:off x="7052703" y="8"/>
            <a:ext cx="2762882" cy="2822131"/>
          </a:xfrm>
          <a:prstGeom prst="rect">
            <a:avLst/>
          </a:prstGeom>
        </p:spPr>
      </p:pic>
      <p:pic>
        <p:nvPicPr>
          <p:cNvPr id="33" name="図 32" descr="ダイアグラム&#10;&#10;自動的に生成された説明">
            <a:extLst>
              <a:ext uri="{FF2B5EF4-FFF2-40B4-BE49-F238E27FC236}">
                <a16:creationId xmlns:a16="http://schemas.microsoft.com/office/drawing/2014/main" id="{8838585A-E1E0-41B6-FEB3-5473031F18E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05" t="490" r="30156" b="7296"/>
          <a:stretch/>
        </p:blipFill>
        <p:spPr>
          <a:xfrm>
            <a:off x="9915178" y="0"/>
            <a:ext cx="2177227" cy="2822121"/>
          </a:xfrm>
          <a:prstGeom prst="rect">
            <a:avLst/>
          </a:prstGeom>
        </p:spPr>
      </p:pic>
      <p:pic>
        <p:nvPicPr>
          <p:cNvPr id="44" name="図 43" descr="ダイアグラム&#10;&#10;自動的に生成された説明">
            <a:extLst>
              <a:ext uri="{FF2B5EF4-FFF2-40B4-BE49-F238E27FC236}">
                <a16:creationId xmlns:a16="http://schemas.microsoft.com/office/drawing/2014/main" id="{C6DCE410-A47F-1799-802A-BD9FC99383F3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35" t="770" r="29646" b="4779"/>
          <a:stretch/>
        </p:blipFill>
        <p:spPr>
          <a:xfrm>
            <a:off x="147702" y="3222242"/>
            <a:ext cx="2178031" cy="2822149"/>
          </a:xfrm>
          <a:prstGeom prst="rect">
            <a:avLst/>
          </a:prstGeom>
        </p:spPr>
      </p:pic>
      <p:pic>
        <p:nvPicPr>
          <p:cNvPr id="46" name="図 45" descr="ダイアグラム&#10;&#10;自動的に生成された説明">
            <a:extLst>
              <a:ext uri="{FF2B5EF4-FFF2-40B4-BE49-F238E27FC236}">
                <a16:creationId xmlns:a16="http://schemas.microsoft.com/office/drawing/2014/main" id="{214DD3AA-DF9D-A2EF-3534-0B2446BFFE7B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990" t="4499" r="26823" b="10840"/>
          <a:stretch/>
        </p:blipFill>
        <p:spPr>
          <a:xfrm>
            <a:off x="2473435" y="3222213"/>
            <a:ext cx="2517557" cy="2822150"/>
          </a:xfrm>
          <a:prstGeom prst="rect">
            <a:avLst/>
          </a:prstGeom>
        </p:spPr>
      </p:pic>
      <p:pic>
        <p:nvPicPr>
          <p:cNvPr id="48" name="図 47" descr="ダイアグラム&#10;&#10;自動的に生成された説明">
            <a:extLst>
              <a:ext uri="{FF2B5EF4-FFF2-40B4-BE49-F238E27FC236}">
                <a16:creationId xmlns:a16="http://schemas.microsoft.com/office/drawing/2014/main" id="{5B29FA11-20E9-5892-BBA2-282C60DBBA81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261" t="584" r="30313" b="4685"/>
          <a:stretch/>
        </p:blipFill>
        <p:spPr>
          <a:xfrm>
            <a:off x="5138694" y="3222213"/>
            <a:ext cx="2102724" cy="2822150"/>
          </a:xfrm>
          <a:prstGeom prst="rect">
            <a:avLst/>
          </a:prstGeom>
        </p:spPr>
      </p:pic>
      <p:pic>
        <p:nvPicPr>
          <p:cNvPr id="50" name="図 49" descr="ダイアグラム&#10;&#10;自動的に生成された説明">
            <a:extLst>
              <a:ext uri="{FF2B5EF4-FFF2-40B4-BE49-F238E27FC236}">
                <a16:creationId xmlns:a16="http://schemas.microsoft.com/office/drawing/2014/main" id="{A7CBB2C9-1164-9541-7A0B-56B9844FFFD6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04" t="397" r="29958" b="7017"/>
          <a:stretch/>
        </p:blipFill>
        <p:spPr>
          <a:xfrm>
            <a:off x="7389120" y="3221276"/>
            <a:ext cx="2179281" cy="2822151"/>
          </a:xfrm>
          <a:prstGeom prst="rect">
            <a:avLst/>
          </a:prstGeom>
        </p:spPr>
      </p:pic>
      <p:pic>
        <p:nvPicPr>
          <p:cNvPr id="52" name="図 51" descr="ダイアグラム, 設計図&#10;&#10;自動的に生成された説明">
            <a:extLst>
              <a:ext uri="{FF2B5EF4-FFF2-40B4-BE49-F238E27FC236}">
                <a16:creationId xmlns:a16="http://schemas.microsoft.com/office/drawing/2014/main" id="{F58F4188-2E17-5B08-107A-EEDF6249E9CE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93" r="28116" b="4756"/>
          <a:stretch/>
        </p:blipFill>
        <p:spPr>
          <a:xfrm>
            <a:off x="9716103" y="3221275"/>
            <a:ext cx="2328193" cy="28221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969004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9373ECFB-F8F8-6CB8-A879-58444B04879D}"/>
              </a:ext>
            </a:extLst>
          </p:cNvPr>
          <p:cNvSpPr txBox="1"/>
          <p:nvPr/>
        </p:nvSpPr>
        <p:spPr>
          <a:xfrm>
            <a:off x="0" y="6444504"/>
            <a:ext cx="121920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2. The secondary structures of the 23 tRNAs encoded in the mitochondrial genome of </a:t>
            </a:r>
            <a:r>
              <a:rPr lang="en-US" altLang="ja-JP" sz="105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urilla</a:t>
            </a:r>
            <a:r>
              <a:rPr lang="en-US" altLang="ja-JP" sz="10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aziliana</a:t>
            </a:r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types of base pairing are indicated by the varying styles of bonds between bases. Each structure is accompanied by the corresponding tRNA type and its position within the </a:t>
            </a:r>
            <a:r>
              <a:rPr lang="en-US" altLang="ja-JP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DNA</a:t>
            </a:r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kumimoji="1" lang="en-US" altLang="ja-JP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A19BC597-0BAE-71A7-5A33-AA9E936BAEE9}"/>
              </a:ext>
            </a:extLst>
          </p:cNvPr>
          <p:cNvSpPr txBox="1"/>
          <p:nvPr/>
        </p:nvSpPr>
        <p:spPr>
          <a:xfrm>
            <a:off x="363239" y="2827550"/>
            <a:ext cx="1923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NA-</a:t>
            </a:r>
            <a:r>
              <a:rPr kumimoji="1" lang="en-US" altLang="ja-JP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s</a:t>
            </a:r>
            <a:endParaRPr kumimoji="1"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391-8452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 descr="ダイアグラム&#10;&#10;自動的に生成された説明">
            <a:extLst>
              <a:ext uri="{FF2B5EF4-FFF2-40B4-BE49-F238E27FC236}">
                <a16:creationId xmlns:a16="http://schemas.microsoft.com/office/drawing/2014/main" id="{9CDC8A7A-E4BF-EA76-6BDD-3773AA86C97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245" r="29424" b="4722"/>
          <a:stretch/>
        </p:blipFill>
        <p:spPr>
          <a:xfrm>
            <a:off x="232093" y="0"/>
            <a:ext cx="2191602" cy="2822149"/>
          </a:xfrm>
          <a:prstGeom prst="rect">
            <a:avLst/>
          </a:prstGeom>
        </p:spPr>
      </p:pic>
      <p:pic>
        <p:nvPicPr>
          <p:cNvPr id="9" name="図 8" descr="ダイアグラム&#10;&#10;自動的に生成された説明">
            <a:extLst>
              <a:ext uri="{FF2B5EF4-FFF2-40B4-BE49-F238E27FC236}">
                <a16:creationId xmlns:a16="http://schemas.microsoft.com/office/drawing/2014/main" id="{5BC30C45-F348-3B5B-A92A-9A643B1E784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08" r="30396" b="4722"/>
          <a:stretch/>
        </p:blipFill>
        <p:spPr>
          <a:xfrm>
            <a:off x="2655788" y="0"/>
            <a:ext cx="2094324" cy="2822149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C2D34EB-4D7C-1831-882C-9683A4F3629A}"/>
              </a:ext>
            </a:extLst>
          </p:cNvPr>
          <p:cNvSpPr txBox="1"/>
          <p:nvPr/>
        </p:nvSpPr>
        <p:spPr>
          <a:xfrm>
            <a:off x="2741336" y="2822148"/>
            <a:ext cx="1923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NA-Gln</a:t>
            </a:r>
          </a:p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487-8546 (complement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図 12" descr="グラフ が含まれている画像&#10;&#10;自動的に生成された説明">
            <a:extLst>
              <a:ext uri="{FF2B5EF4-FFF2-40B4-BE49-F238E27FC236}">
                <a16:creationId xmlns:a16="http://schemas.microsoft.com/office/drawing/2014/main" id="{C108DDB9-D589-7B8F-9C5F-7A49B8F9C2C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30" r="29694" b="7426"/>
          <a:stretch/>
        </p:blipFill>
        <p:spPr>
          <a:xfrm>
            <a:off x="4982205" y="0"/>
            <a:ext cx="2214405" cy="2822148"/>
          </a:xfrm>
          <a:prstGeom prst="rect">
            <a:avLst/>
          </a:prstGeom>
        </p:spPr>
      </p:pic>
      <p:pic>
        <p:nvPicPr>
          <p:cNvPr id="15" name="図 14" descr="ダイアグラム&#10;&#10;自動的に生成された説明">
            <a:extLst>
              <a:ext uri="{FF2B5EF4-FFF2-40B4-BE49-F238E27FC236}">
                <a16:creationId xmlns:a16="http://schemas.microsoft.com/office/drawing/2014/main" id="{F3E9C994-7FD4-C562-F62D-C5E08436B26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756" r="30665" b="7234"/>
          <a:stretch/>
        </p:blipFill>
        <p:spPr>
          <a:xfrm>
            <a:off x="7428703" y="0"/>
            <a:ext cx="2101067" cy="2822148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27EAA23-1EB7-0AD3-A4B6-A57E67040495}"/>
              </a:ext>
            </a:extLst>
          </p:cNvPr>
          <p:cNvSpPr txBox="1"/>
          <p:nvPr/>
        </p:nvSpPr>
        <p:spPr>
          <a:xfrm>
            <a:off x="5134386" y="2822148"/>
            <a:ext cx="1923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NA-Leu</a:t>
            </a:r>
          </a:p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48-8610 (complement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31B4456-00BB-81AF-549B-22A46DF4D503}"/>
              </a:ext>
            </a:extLst>
          </p:cNvPr>
          <p:cNvSpPr txBox="1"/>
          <p:nvPr/>
        </p:nvSpPr>
        <p:spPr>
          <a:xfrm>
            <a:off x="7517622" y="2822148"/>
            <a:ext cx="1923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NA-</a:t>
            </a:r>
            <a:r>
              <a:rPr kumimoji="1" lang="en-US" altLang="ja-JP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n</a:t>
            </a:r>
            <a:endParaRPr kumimoji="1"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769-8830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omplement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図 19" descr="ダイアグラム&#10;&#10;自動的に生成された説明">
            <a:extLst>
              <a:ext uri="{FF2B5EF4-FFF2-40B4-BE49-F238E27FC236}">
                <a16:creationId xmlns:a16="http://schemas.microsoft.com/office/drawing/2014/main" id="{AFE69893-B4C8-B816-6B16-00BDA0EDD5B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84" r="29856" b="7234"/>
          <a:stretch/>
        </p:blipFill>
        <p:spPr>
          <a:xfrm>
            <a:off x="9761863" y="0"/>
            <a:ext cx="2198046" cy="2822157"/>
          </a:xfrm>
          <a:prstGeom prst="rect">
            <a:avLst/>
          </a:prstGeom>
        </p:spPr>
      </p:pic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BC26752C-1E24-DEBF-F36A-C464C284037D}"/>
              </a:ext>
            </a:extLst>
          </p:cNvPr>
          <p:cNvSpPr txBox="1"/>
          <p:nvPr/>
        </p:nvSpPr>
        <p:spPr>
          <a:xfrm>
            <a:off x="9899272" y="2822148"/>
            <a:ext cx="1923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NA-Arg</a:t>
            </a:r>
          </a:p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11-9570 (complement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" name="図 25" descr="ダイアグラム&#10;&#10;自動的に生成された説明">
            <a:extLst>
              <a:ext uri="{FF2B5EF4-FFF2-40B4-BE49-F238E27FC236}">
                <a16:creationId xmlns:a16="http://schemas.microsoft.com/office/drawing/2014/main" id="{C2ECE831-6144-DA9B-F9E4-C4564675273E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94" r="27266" b="7330"/>
          <a:stretch/>
        </p:blipFill>
        <p:spPr>
          <a:xfrm>
            <a:off x="176728" y="3222251"/>
            <a:ext cx="2482727" cy="2822150"/>
          </a:xfrm>
          <a:prstGeom prst="rect">
            <a:avLst/>
          </a:prstGeom>
        </p:spPr>
      </p:pic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F33C76F8-3D7E-036F-BDC6-179D92D6EB73}"/>
              </a:ext>
            </a:extLst>
          </p:cNvPr>
          <p:cNvSpPr txBox="1"/>
          <p:nvPr/>
        </p:nvSpPr>
        <p:spPr>
          <a:xfrm>
            <a:off x="456477" y="6033671"/>
            <a:ext cx="1923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NA-Glu</a:t>
            </a:r>
          </a:p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78-9643 (complement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1" name="図 30" descr="ダイアグラム&#10;&#10;自動的に生成された説明">
            <a:extLst>
              <a:ext uri="{FF2B5EF4-FFF2-40B4-BE49-F238E27FC236}">
                <a16:creationId xmlns:a16="http://schemas.microsoft.com/office/drawing/2014/main" id="{77A3A4EB-E18C-E83B-8B43-70F2C8B37CC1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93" r="29856" b="4722"/>
          <a:stretch/>
        </p:blipFill>
        <p:spPr>
          <a:xfrm>
            <a:off x="2836183" y="3227660"/>
            <a:ext cx="2130286" cy="2816735"/>
          </a:xfrm>
          <a:prstGeom prst="rect">
            <a:avLst/>
          </a:prstGeom>
        </p:spPr>
      </p:pic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86845D6B-5822-DA00-9B99-3E686A7C4A4E}"/>
              </a:ext>
            </a:extLst>
          </p:cNvPr>
          <p:cNvSpPr txBox="1"/>
          <p:nvPr/>
        </p:nvSpPr>
        <p:spPr>
          <a:xfrm>
            <a:off x="2935306" y="6033754"/>
            <a:ext cx="1923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NA-Met</a:t>
            </a:r>
          </a:p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377-10440 (complement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4" name="図 33" descr="ダイアグラム&#10;&#10;自動的に生成された説明">
            <a:extLst>
              <a:ext uri="{FF2B5EF4-FFF2-40B4-BE49-F238E27FC236}">
                <a16:creationId xmlns:a16="http://schemas.microsoft.com/office/drawing/2014/main" id="{F71AFE2C-F0D8-6CB9-7325-330665D4EC34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28" r="24892" b="7330"/>
          <a:stretch/>
        </p:blipFill>
        <p:spPr>
          <a:xfrm>
            <a:off x="5143197" y="3227661"/>
            <a:ext cx="2735693" cy="2822136"/>
          </a:xfrm>
          <a:prstGeom prst="rect">
            <a:avLst/>
          </a:prstGeom>
        </p:spPr>
      </p:pic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933AE52A-E847-5D5E-91F9-144349F1E84B}"/>
              </a:ext>
            </a:extLst>
          </p:cNvPr>
          <p:cNvSpPr txBox="1"/>
          <p:nvPr/>
        </p:nvSpPr>
        <p:spPr>
          <a:xfrm>
            <a:off x="5547056" y="6033671"/>
            <a:ext cx="1923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NA-Ser</a:t>
            </a:r>
          </a:p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818-10888 (complement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8" name="図 37" descr="ダイアグラム&#10;&#10;自動的に生成された説明">
            <a:extLst>
              <a:ext uri="{FF2B5EF4-FFF2-40B4-BE49-F238E27FC236}">
                <a16:creationId xmlns:a16="http://schemas.microsoft.com/office/drawing/2014/main" id="{F6215A76-F093-9A49-A081-AC7F30D3BEE4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644" r="33364" b="7330"/>
          <a:stretch/>
        </p:blipFill>
        <p:spPr>
          <a:xfrm>
            <a:off x="8055618" y="3227660"/>
            <a:ext cx="1853221" cy="2822151"/>
          </a:xfrm>
          <a:prstGeom prst="rect">
            <a:avLst/>
          </a:prstGeom>
        </p:spPr>
      </p:pic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1F74D507-0FD0-82D1-E729-4B7D322267A6}"/>
              </a:ext>
            </a:extLst>
          </p:cNvPr>
          <p:cNvSpPr txBox="1"/>
          <p:nvPr/>
        </p:nvSpPr>
        <p:spPr>
          <a:xfrm>
            <a:off x="8015706" y="6033671"/>
            <a:ext cx="1923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NA-Ser</a:t>
            </a:r>
          </a:p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877-10934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3" name="図 42" descr="ダイアグラム, 設計図&#10;&#10;自動的に生成された説明">
            <a:extLst>
              <a:ext uri="{FF2B5EF4-FFF2-40B4-BE49-F238E27FC236}">
                <a16:creationId xmlns:a16="http://schemas.microsoft.com/office/drawing/2014/main" id="{90E18F19-9C53-485F-98A9-4F088E372B5B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02" r="33202" b="7330"/>
          <a:stretch/>
        </p:blipFill>
        <p:spPr>
          <a:xfrm>
            <a:off x="10085567" y="3230316"/>
            <a:ext cx="1929704" cy="2822151"/>
          </a:xfrm>
          <a:prstGeom prst="rect">
            <a:avLst/>
          </a:prstGeom>
        </p:spPr>
      </p:pic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BD8E9471-9CAD-B22A-702D-0600998CCDEA}"/>
              </a:ext>
            </a:extLst>
          </p:cNvPr>
          <p:cNvSpPr txBox="1"/>
          <p:nvPr/>
        </p:nvSpPr>
        <p:spPr>
          <a:xfrm>
            <a:off x="10102946" y="6044394"/>
            <a:ext cx="1923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NA-Ser</a:t>
            </a:r>
          </a:p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936-10993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35547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9373ECFB-F8F8-6CB8-A879-58444B04879D}"/>
              </a:ext>
            </a:extLst>
          </p:cNvPr>
          <p:cNvSpPr txBox="1"/>
          <p:nvPr/>
        </p:nvSpPr>
        <p:spPr>
          <a:xfrm>
            <a:off x="0" y="6444504"/>
            <a:ext cx="121920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2. The secondary structures of the 23 tRNAs encoded in the mitochondrial genome of </a:t>
            </a:r>
            <a:r>
              <a:rPr lang="en-US" altLang="ja-JP" sz="105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urilla</a:t>
            </a:r>
            <a:r>
              <a:rPr lang="en-US" altLang="ja-JP" sz="10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aziliana</a:t>
            </a:r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types of base pairing are indicated by the varying styles of bonds between bases. Each structure is accompanied by the corresponding tRNA type and its position within the </a:t>
            </a:r>
            <a:r>
              <a:rPr lang="en-US" altLang="ja-JP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DNA</a:t>
            </a:r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kumimoji="1" lang="en-US" altLang="ja-JP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A19BC597-0BAE-71A7-5A33-AA9E936BAEE9}"/>
              </a:ext>
            </a:extLst>
          </p:cNvPr>
          <p:cNvSpPr txBox="1"/>
          <p:nvPr/>
        </p:nvSpPr>
        <p:spPr>
          <a:xfrm>
            <a:off x="1503436" y="2832963"/>
            <a:ext cx="1923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NA-</a:t>
            </a:r>
            <a:r>
              <a:rPr kumimoji="1" lang="en-US" altLang="ja-JP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</a:t>
            </a:r>
            <a:endParaRPr kumimoji="1"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334-12396 (complement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図 5" descr="ダイアグラム, 概略図&#10;&#10;自動的に生成された説明">
            <a:extLst>
              <a:ext uri="{FF2B5EF4-FFF2-40B4-BE49-F238E27FC236}">
                <a16:creationId xmlns:a16="http://schemas.microsoft.com/office/drawing/2014/main" id="{F4B8C742-B46E-88BE-AE29-FA9FBD1CE8A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57" t="4770" r="27212" b="6557"/>
          <a:stretch/>
        </p:blipFill>
        <p:spPr>
          <a:xfrm>
            <a:off x="1287617" y="0"/>
            <a:ext cx="2354866" cy="2822149"/>
          </a:xfrm>
          <a:prstGeom prst="rect">
            <a:avLst/>
          </a:prstGeom>
        </p:spPr>
      </p:pic>
      <p:pic>
        <p:nvPicPr>
          <p:cNvPr id="8" name="図 7" descr="ダイアグラム&#10;&#10;自動的に生成された説明">
            <a:extLst>
              <a:ext uri="{FF2B5EF4-FFF2-40B4-BE49-F238E27FC236}">
                <a16:creationId xmlns:a16="http://schemas.microsoft.com/office/drawing/2014/main" id="{346FE3D6-191F-EEA7-9E06-F240FFDB647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111" r="27968" b="7426"/>
          <a:stretch/>
        </p:blipFill>
        <p:spPr>
          <a:xfrm>
            <a:off x="4930100" y="0"/>
            <a:ext cx="2396977" cy="2822149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246659C-5859-7450-FF93-B87238A345F5}"/>
              </a:ext>
            </a:extLst>
          </p:cNvPr>
          <p:cNvSpPr txBox="1"/>
          <p:nvPr/>
        </p:nvSpPr>
        <p:spPr>
          <a:xfrm>
            <a:off x="5134386" y="2832963"/>
            <a:ext cx="1923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NA-Ile</a:t>
            </a:r>
          </a:p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224-13291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図 13" descr="ダイアグラム&#10;&#10;自動的に生成された説明">
            <a:extLst>
              <a:ext uri="{FF2B5EF4-FFF2-40B4-BE49-F238E27FC236}">
                <a16:creationId xmlns:a16="http://schemas.microsoft.com/office/drawing/2014/main" id="{4A8492FB-2C02-71A2-7147-E031F2AE8EE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96" r="30018" b="7137"/>
          <a:stretch/>
        </p:blipFill>
        <p:spPr>
          <a:xfrm>
            <a:off x="8614694" y="0"/>
            <a:ext cx="2289689" cy="2822149"/>
          </a:xfrm>
          <a:prstGeom prst="rect">
            <a:avLst/>
          </a:prstGeom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F22BBE3E-97CD-1FF8-58B9-492469764E6F}"/>
              </a:ext>
            </a:extLst>
          </p:cNvPr>
          <p:cNvSpPr txBox="1"/>
          <p:nvPr/>
        </p:nvSpPr>
        <p:spPr>
          <a:xfrm>
            <a:off x="8797924" y="2832963"/>
            <a:ext cx="1923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NA-Lys</a:t>
            </a:r>
          </a:p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226-14289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89063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</TotalTime>
  <Words>226</Words>
  <Application>Microsoft Office PowerPoint</Application>
  <PresentationFormat>ワイド画面</PresentationFormat>
  <Paragraphs>52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溝端 秀彬</dc:creator>
  <cp:lastModifiedBy>溝端 秀彬</cp:lastModifiedBy>
  <cp:revision>11</cp:revision>
  <dcterms:created xsi:type="dcterms:W3CDTF">2023-06-11T12:21:30Z</dcterms:created>
  <dcterms:modified xsi:type="dcterms:W3CDTF">2023-06-14T08:27:52Z</dcterms:modified>
</cp:coreProperties>
</file>